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8465" autoAdjust="0"/>
    <p:restoredTop sz="94660"/>
  </p:normalViewPr>
  <p:slideViewPr>
    <p:cSldViewPr snapToGrid="0">
      <p:cViewPr varScale="1">
        <p:scale>
          <a:sx n="68" d="100"/>
          <a:sy n="68" d="100"/>
        </p:scale>
        <p:origin x="84" y="9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31945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0067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5149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8885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3640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5543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1560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3653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3556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8269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396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F9972-94A9-43B3-B1B7-5C256C0CAED3}" type="datetimeFigureOut">
              <a:rPr lang="it-IT" smtClean="0"/>
              <a:t>03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6B3EB9-B6A9-4FE5-A40E-1585CEEFF1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244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/>
          <p:cNvSpPr txBox="1"/>
          <p:nvPr/>
        </p:nvSpPr>
        <p:spPr>
          <a:xfrm>
            <a:off x="498764" y="249381"/>
            <a:ext cx="11205556" cy="4616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|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a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curves and Pearson correlation coefficients among dr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omas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DVI from UAV-Sequoia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ctor-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eenSeeke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P-value &lt;0.0001, **0.0001&lt;P-value &lt;0.001, *0.001&lt;P-value &lt;0.01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Immagine 2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069" y="953588"/>
            <a:ext cx="11969931" cy="57868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91043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74</TotalTime>
  <Words>3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Emanuele Condorelli</dc:creator>
  <cp:lastModifiedBy>Giuseppe Emanuele Condorelli</cp:lastModifiedBy>
  <cp:revision>16</cp:revision>
  <dcterms:created xsi:type="dcterms:W3CDTF">2017-12-15T14:47:10Z</dcterms:created>
  <dcterms:modified xsi:type="dcterms:W3CDTF">2018-05-03T07:13:23Z</dcterms:modified>
</cp:coreProperties>
</file>